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1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D2C14-B527-47A8-990B-44DB040284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11C8C6-D4BA-4350-881C-9C0AE3A0CC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C5DF38-2D25-4433-938F-275B86FC7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F6F04-D138-4A9A-A1D2-B614E44A2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1B3436-AEFA-432C-843C-AD467CBF9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9308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DE784-95BD-4EDA-91E5-219A3B40E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B73C8C-8EDC-4E80-8E57-29CE8FDCEC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BD65DE-BD71-4B4F-8AB4-EAB96D570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F5C85-F172-4319-9023-6F6BEDF5A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E6EE7F-E6B1-429F-A1E4-F47713FB0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0177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DE964D-1527-4990-BFFF-83726109AE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B6241F-2173-47B5-BEBA-DDFC5D9F7E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13728-86C2-4601-907F-19961E3EF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012DA3-BEC7-4428-91B1-E4ED09CBA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7F139-ADAD-4501-BFE1-352C010BD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1970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67B02-B89E-406D-BB29-61653252D8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EF2F75-FAB8-4108-A085-4BC327A696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0688D6-30EB-4023-87B2-A3DBDABA1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EEAB2-9574-4E8B-A8BE-01E3C16FE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64E470-339E-4DB6-B5C9-FAA5A7DF4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646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70C2B8-98F9-4E1A-812A-3D2984104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0D9CE3-DA19-4444-9AF8-75D8D86886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39A25-2DEE-46C2-95BE-8173EC46B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55296-6C2B-487C-ABAA-95583F6FD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00C6C4-C58A-4920-8960-1965C006D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275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FE202-5767-4297-8D95-4BFC4B851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7F0ABD-DBA5-44C6-8E1E-F3B825A91D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59F6E8-BF25-4932-BA2D-DA506F9182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DF5651-DFF1-4D15-A7A4-9DF19F946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7DC1A0-552B-4A8E-BBD7-7758568E3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D1C2AD-5A94-42F1-AF1D-C308891A1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8965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224C3-272D-4E71-9602-589D10257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C68FF4-0479-4194-B7DC-60F7E29C0E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19DBA2-DCE7-4A6C-9F10-55D061E9A9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167A82-79F0-4B0F-A61D-FB2EB658AE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540AF7-7C28-431A-9E08-30E9BFAA38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96C110-9936-4C82-983E-3363200D3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FD4B15-F1ED-4B16-8D20-A81E8F58D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4CC3AFB-80DF-4F5D-BD79-FFC079934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8848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B4088-9747-463A-9A1C-760A921F4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78DCB7-0FCE-4BE4-BDF6-DF8777F50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093EAB-DD1E-4539-B051-F3DCA3EF4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1D8F3E-367C-4395-B686-A6A70B27E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071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F6F645-E050-4CB5-869F-601B51142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455D27-4CE6-4501-B195-9A4044B16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8F0E4-9FEB-4835-8EEA-49D1817A5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396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11825-6F1C-429C-B8F7-95476C234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B19A97-A8D0-49BE-8C19-DD54DFA8A2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9C019C-3ED2-44B8-AEA7-37F2A63BD8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DD60A4-2E30-459A-A3B2-63BDB4A9D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2721CB-B020-434B-BC80-F3208686F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02A151-4ABD-4D8D-BA67-83549F16A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876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8150EB-0305-4441-9689-401F1D7157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931527-C352-436E-BA0F-3A2E7A191D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B68DE2-388D-4C33-9422-F631C1F953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46874E-D5E1-4291-8EAE-05281FC13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1E65AF-D11A-4EE7-95CE-B9E1D6642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7DFA-C7DB-444C-A950-29451F67F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6030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526CC2-B6DD-4FD3-98A2-8833D64E3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5D8389-E63A-4DAA-9E79-D1D5022484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AA17BD-4388-4608-9999-6B33D6EE59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78F78-A321-4C05-ADC3-702612D19E49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9E40BF-85FA-42E5-A6CF-63EBCE2992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45A41E-B051-4FBE-B0C9-0ED7DD1AB4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084C7-0A5B-4AF9-B190-279BF709C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8183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B278C80B-9CEB-476B-BB19-745469A03B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0516805"/>
              </p:ext>
            </p:extLst>
          </p:nvPr>
        </p:nvGraphicFramePr>
        <p:xfrm>
          <a:off x="581251" y="167654"/>
          <a:ext cx="10906939" cy="5851971"/>
        </p:xfrm>
        <a:graphic>
          <a:graphicData uri="http://schemas.openxmlformats.org/drawingml/2006/table">
            <a:tbl>
              <a:tblPr firstRow="1" firstCol="1" bandRow="1"/>
              <a:tblGrid>
                <a:gridCol w="2660307">
                  <a:extLst>
                    <a:ext uri="{9D8B030D-6E8A-4147-A177-3AD203B41FA5}">
                      <a16:colId xmlns:a16="http://schemas.microsoft.com/office/drawing/2014/main" val="2824164056"/>
                    </a:ext>
                  </a:extLst>
                </a:gridCol>
                <a:gridCol w="2623602">
                  <a:extLst>
                    <a:ext uri="{9D8B030D-6E8A-4147-A177-3AD203B41FA5}">
                      <a16:colId xmlns:a16="http://schemas.microsoft.com/office/drawing/2014/main" val="1461370461"/>
                    </a:ext>
                  </a:extLst>
                </a:gridCol>
                <a:gridCol w="2999428">
                  <a:extLst>
                    <a:ext uri="{9D8B030D-6E8A-4147-A177-3AD203B41FA5}">
                      <a16:colId xmlns:a16="http://schemas.microsoft.com/office/drawing/2014/main" val="2092377386"/>
                    </a:ext>
                  </a:extLst>
                </a:gridCol>
                <a:gridCol w="2623602">
                  <a:extLst>
                    <a:ext uri="{9D8B030D-6E8A-4147-A177-3AD203B41FA5}">
                      <a16:colId xmlns:a16="http://schemas.microsoft.com/office/drawing/2014/main" val="4053958616"/>
                    </a:ext>
                  </a:extLst>
                </a:gridCol>
              </a:tblGrid>
              <a:tr h="1794603"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hole grains, roots, and tubers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egetables 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ruits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lk and dairy foods</a:t>
                      </a:r>
                      <a:endParaRPr lang="en-US" sz="85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1008496"/>
                  </a:ext>
                </a:extLst>
              </a:tr>
              <a:tr h="1850505"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t, fish and egg</a:t>
                      </a:r>
                      <a:endParaRPr lang="en-US" sz="85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gumes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ts and seeds</a:t>
                      </a:r>
                      <a:endParaRPr lang="en-US" sz="85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s and oils</a:t>
                      </a:r>
                      <a:endParaRPr lang="en-US" sz="85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608737"/>
                  </a:ext>
                </a:extLst>
              </a:tr>
              <a:tr h="1890193"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ded sugar and SSB</a:t>
                      </a:r>
                      <a:endParaRPr lang="en-US" sz="85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80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lt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cohol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800" dirty="0">
                          <a:effectLst/>
                          <a:latin typeface="Verdana" panose="020B060403050404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endParaRPr lang="en-GB" sz="800" b="1" kern="1200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algn="l" defTabSz="914400" rtl="0" eaLnBrk="1" latinLnBrk="0" hangingPunct="1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e Et-HEI </a:t>
                      </a:r>
                      <a:endParaRPr lang="en-US" sz="800" dirty="0">
                        <a:effectLst/>
                        <a:latin typeface="Verdana" panose="020B060403050404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45" marR="64945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32352921"/>
                  </a:ext>
                </a:extLst>
              </a:tr>
            </a:tbl>
          </a:graphicData>
        </a:graphic>
      </p:graphicFrame>
      <p:pic>
        <p:nvPicPr>
          <p:cNvPr id="41" name="Picture 40">
            <a:extLst>
              <a:ext uri="{FF2B5EF4-FFF2-40B4-BE49-F238E27FC236}">
                <a16:creationId xmlns:a16="http://schemas.microsoft.com/office/drawing/2014/main" id="{31498841-5075-448B-96C1-8856BC93B61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976" y="202903"/>
            <a:ext cx="2461898" cy="1738538"/>
          </a:xfrm>
          <a:prstGeom prst="rect">
            <a:avLst/>
          </a:prstGeom>
          <a:noFill/>
          <a:ln>
            <a:noFill/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EE787634-55EC-45DD-97F8-2CD2641B929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0281" y="202903"/>
            <a:ext cx="2462126" cy="1738538"/>
          </a:xfrm>
          <a:prstGeom prst="rect">
            <a:avLst/>
          </a:prstGeom>
          <a:noFill/>
          <a:ln>
            <a:noFill/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649D1F48-FD7B-49EE-BF8C-C9DEC0DC4AE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9814" y="176869"/>
            <a:ext cx="2733735" cy="1738626"/>
          </a:xfrm>
          <a:prstGeom prst="rect">
            <a:avLst/>
          </a:prstGeom>
          <a:noFill/>
          <a:ln>
            <a:noFill/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26473DAF-13C5-4551-B205-FF2AC50B057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68710" y="202902"/>
            <a:ext cx="2378915" cy="1675295"/>
          </a:xfrm>
          <a:prstGeom prst="rect">
            <a:avLst/>
          </a:prstGeom>
          <a:noFill/>
          <a:ln>
            <a:noFill/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DC2FF185-BDB9-4BCB-8887-37AD9342FB6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975" y="2223909"/>
            <a:ext cx="2398109" cy="1616428"/>
          </a:xfrm>
          <a:prstGeom prst="rect">
            <a:avLst/>
          </a:prstGeom>
          <a:noFill/>
          <a:ln>
            <a:noFill/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549AC886-633B-4D92-88FE-66EFA9F4400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0281" y="2223909"/>
            <a:ext cx="2462126" cy="1669073"/>
          </a:xfrm>
          <a:prstGeom prst="rect">
            <a:avLst/>
          </a:prstGeom>
          <a:noFill/>
          <a:ln>
            <a:noFill/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0D73D6BE-EBC1-4797-8E3C-E586586889C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3603" y="2223909"/>
            <a:ext cx="2669946" cy="1638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F51DD6EC-FBB4-4CED-8494-8E9C9A4372A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68711" y="2223909"/>
            <a:ext cx="2378914" cy="1632997"/>
          </a:xfrm>
          <a:prstGeom prst="rect">
            <a:avLst/>
          </a:prstGeom>
          <a:noFill/>
          <a:ln>
            <a:noFill/>
          </a:ln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DBA2AB2-AD27-4C5C-92CD-0A84EAD92708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975" y="4143148"/>
            <a:ext cx="2281730" cy="1671724"/>
          </a:xfrm>
          <a:prstGeom prst="rect">
            <a:avLst/>
          </a:prstGeom>
          <a:noFill/>
          <a:ln>
            <a:noFill/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DDF52890-1BE6-4378-8AD0-385C4A8F1616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0601" y="4161457"/>
            <a:ext cx="2355304" cy="1671518"/>
          </a:xfrm>
          <a:prstGeom prst="rect">
            <a:avLst/>
          </a:prstGeom>
          <a:noFill/>
          <a:ln>
            <a:noFill/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79784ED6-B0FD-494F-869E-7ABB389A3BD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3602" y="4143148"/>
            <a:ext cx="2611757" cy="1671436"/>
          </a:xfrm>
          <a:prstGeom prst="rect">
            <a:avLst/>
          </a:prstGeom>
          <a:noFill/>
          <a:ln>
            <a:noFill/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5B01B1E4-3CEE-4786-AAF8-82B8B93E46F4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968711" y="4093667"/>
            <a:ext cx="2378916" cy="1739308"/>
          </a:xfrm>
          <a:prstGeom prst="rect">
            <a:avLst/>
          </a:prstGeom>
          <a:noFill/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C6158CF-2320-40AF-819B-E05BF13E3CE2}"/>
              </a:ext>
            </a:extLst>
          </p:cNvPr>
          <p:cNvSpPr txBox="1"/>
          <p:nvPr/>
        </p:nvSpPr>
        <p:spPr>
          <a:xfrm>
            <a:off x="402672" y="6105615"/>
            <a:ext cx="11543252" cy="752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>
              <a:lnSpc>
                <a:spcPct val="125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</a:rPr>
              <a:t>Supplemental Figure 2. </a:t>
            </a:r>
            <a:r>
              <a:rPr lang="en-GB" dirty="0">
                <a:latin typeface="Times New Roman" panose="02020603050405020304" pitchFamily="18" charset="0"/>
              </a:rPr>
              <a:t>The total and 11 components score distribution of the Ethiopian healthy eating index in a sample of 494 women aged 15-49 years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850" dirty="0">
              <a:effectLst/>
              <a:latin typeface="Verdana" panose="020B060403050404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8560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67</Words>
  <Application>Microsoft Office PowerPoint</Application>
  <PresentationFormat>Widescreen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Verdan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kele, Tesfaye Hailu</dc:creator>
  <cp:lastModifiedBy>rdserver1</cp:lastModifiedBy>
  <cp:revision>3</cp:revision>
  <dcterms:created xsi:type="dcterms:W3CDTF">2022-11-22T13:16:52Z</dcterms:created>
  <dcterms:modified xsi:type="dcterms:W3CDTF">2023-01-13T15:43:05Z</dcterms:modified>
</cp:coreProperties>
</file>